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88C9AC-CB13-4CBC-ACF3-C99F357379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AD197-0D23-4F1C-A98F-312505923E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8AB7A-622A-4509-8196-8D416F18C5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FBDB5-4950-4D17-85E0-3B98756889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D1F09-FE43-4E6B-A6DD-21B1AFD2B9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60FE5-21B4-4FE6-865F-ADE8C62FBE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83C4D-2F2A-4E1D-8C31-BA7AE8E401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D002C-BA66-4DF5-B17F-5F2DED3C11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B0BE2-8688-4CCC-A088-C1516F326B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B237F-042F-4A94-8773-18F1BB7E46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71B38-CE18-4111-BCA8-4FAC2EE8F2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DE14F-164A-44CA-B120-D80C27312E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8893919-2BCD-4C02-B6B9-BF93C88891E7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B3B10BD-2BA4-4A37-92B9-8866FCEFFBB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線コネクタ 4"/>
          <p:cNvSpPr/>
          <p:nvPr/>
        </p:nvSpPr>
        <p:spPr>
          <a:xfrm>
            <a:off x="380880" y="2606760"/>
            <a:ext cx="62485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544320" y="2570040"/>
            <a:ext cx="89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uthor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1757520" y="2570040"/>
            <a:ext cx="1211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e (Year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2978280" y="2570040"/>
            <a:ext cx="83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d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4364640" y="2570040"/>
            <a:ext cx="50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t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5653800" y="2570040"/>
            <a:ext cx="104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fere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2977920" y="2978280"/>
            <a:ext cx="77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em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2977920" y="3311640"/>
            <a:ext cx="77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em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2977920" y="3656160"/>
            <a:ext cx="77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em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2977920" y="3987720"/>
            <a:ext cx="77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em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2976480" y="4344840"/>
            <a:ext cx="59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380880" y="2978280"/>
            <a:ext cx="152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ifert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6"/>
          <p:cNvSpPr/>
          <p:nvPr/>
        </p:nvSpPr>
        <p:spPr>
          <a:xfrm>
            <a:off x="380880" y="3311640"/>
            <a:ext cx="152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g and M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7"/>
          <p:cNvSpPr/>
          <p:nvPr/>
        </p:nvSpPr>
        <p:spPr>
          <a:xfrm>
            <a:off x="380880" y="3656160"/>
            <a:ext cx="152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in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380880" y="3987720"/>
            <a:ext cx="184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de and Kusam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380880" y="4344840"/>
            <a:ext cx="184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orkmaz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0"/>
          <p:cNvSpPr/>
          <p:nvPr/>
        </p:nvSpPr>
        <p:spPr>
          <a:xfrm>
            <a:off x="2233080" y="297828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1"/>
          <p:cNvSpPr/>
          <p:nvPr/>
        </p:nvSpPr>
        <p:spPr>
          <a:xfrm>
            <a:off x="2233080" y="33116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2"/>
          <p:cNvSpPr/>
          <p:nvPr/>
        </p:nvSpPr>
        <p:spPr>
          <a:xfrm>
            <a:off x="2233080" y="365616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3"/>
          <p:cNvSpPr/>
          <p:nvPr/>
        </p:nvSpPr>
        <p:spPr>
          <a:xfrm>
            <a:off x="2233080" y="398772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4"/>
          <p:cNvSpPr/>
          <p:nvPr/>
        </p:nvSpPr>
        <p:spPr>
          <a:xfrm>
            <a:off x="2233080" y="434484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5"/>
          <p:cNvSpPr/>
          <p:nvPr/>
        </p:nvSpPr>
        <p:spPr>
          <a:xfrm>
            <a:off x="6004440" y="297828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6"/>
          <p:cNvSpPr/>
          <p:nvPr/>
        </p:nvSpPr>
        <p:spPr>
          <a:xfrm>
            <a:off x="6004440" y="33116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7"/>
          <p:cNvSpPr/>
          <p:nvPr/>
        </p:nvSpPr>
        <p:spPr>
          <a:xfrm>
            <a:off x="6015600" y="365616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8"/>
          <p:cNvSpPr/>
          <p:nvPr/>
        </p:nvSpPr>
        <p:spPr>
          <a:xfrm>
            <a:off x="6004440" y="398772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9"/>
          <p:cNvSpPr/>
          <p:nvPr/>
        </p:nvSpPr>
        <p:spPr>
          <a:xfrm>
            <a:off x="6004440" y="43448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0"/>
          <p:cNvSpPr/>
          <p:nvPr/>
        </p:nvSpPr>
        <p:spPr>
          <a:xfrm>
            <a:off x="3850200" y="2978280"/>
            <a:ext cx="169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erficial parot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1"/>
          <p:cNvSpPr/>
          <p:nvPr/>
        </p:nvSpPr>
        <p:spPr>
          <a:xfrm>
            <a:off x="3844080" y="3656160"/>
            <a:ext cx="123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ep parot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2"/>
          <p:cNvSpPr/>
          <p:nvPr/>
        </p:nvSpPr>
        <p:spPr>
          <a:xfrm>
            <a:off x="3844080" y="4691160"/>
            <a:ext cx="123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ep parot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3"/>
          <p:cNvSpPr/>
          <p:nvPr/>
        </p:nvSpPr>
        <p:spPr>
          <a:xfrm>
            <a:off x="3846240" y="3311640"/>
            <a:ext cx="192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bmandibular gla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4"/>
          <p:cNvSpPr/>
          <p:nvPr/>
        </p:nvSpPr>
        <p:spPr>
          <a:xfrm>
            <a:off x="3844080" y="4344840"/>
            <a:ext cx="123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ep parot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5"/>
          <p:cNvSpPr/>
          <p:nvPr/>
        </p:nvSpPr>
        <p:spPr>
          <a:xfrm>
            <a:off x="3845160" y="3987720"/>
            <a:ext cx="141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uccal mucos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6"/>
          <p:cNvSpPr/>
          <p:nvPr/>
        </p:nvSpPr>
        <p:spPr>
          <a:xfrm>
            <a:off x="380880" y="4691160"/>
            <a:ext cx="152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is ca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7"/>
          <p:cNvSpPr/>
          <p:nvPr/>
        </p:nvSpPr>
        <p:spPr>
          <a:xfrm>
            <a:off x="2233080" y="4691160"/>
            <a:ext cx="38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38"/>
          <p:cNvSpPr/>
          <p:nvPr/>
        </p:nvSpPr>
        <p:spPr>
          <a:xfrm>
            <a:off x="2977920" y="4691160"/>
            <a:ext cx="776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em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線コネクタ 40"/>
          <p:cNvSpPr/>
          <p:nvPr/>
        </p:nvSpPr>
        <p:spPr>
          <a:xfrm>
            <a:off x="380880" y="2911320"/>
            <a:ext cx="62485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直線コネクタ 41"/>
          <p:cNvSpPr/>
          <p:nvPr/>
        </p:nvSpPr>
        <p:spPr>
          <a:xfrm>
            <a:off x="380880" y="5103720"/>
            <a:ext cx="62485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38"/>
          <p:cNvSpPr/>
          <p:nvPr/>
        </p:nvSpPr>
        <p:spPr>
          <a:xfrm>
            <a:off x="1728720" y="1846440"/>
            <a:ext cx="3177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mmary of the reported case o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pomatous pleomorphic adenoma</a:t>
            </a: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3"/>
          <p:cNvSpPr/>
          <p:nvPr/>
        </p:nvSpPr>
        <p:spPr>
          <a:xfrm>
            <a:off x="3042720" y="8317080"/>
            <a:ext cx="91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21T23:35:25Z</dcterms:created>
  <dc:creator>コンドウ タケシ</dc:creator>
  <dc:description/>
  <dc:language>en-US</dc:language>
  <cp:lastModifiedBy>コンドウ タケシ</cp:lastModifiedBy>
  <dcterms:modified xsi:type="dcterms:W3CDTF">2009-05-22T04:52:58Z</dcterms:modified>
  <cp:revision>7</cp:revision>
  <dc:subject/>
  <dc:title>スライド 1</dc:title>
</cp:coreProperties>
</file>